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59"/>
    <p:restoredTop sz="94694"/>
  </p:normalViewPr>
  <p:slideViewPr>
    <p:cSldViewPr snapToGrid="0" snapToObjects="1">
      <p:cViewPr varScale="1">
        <p:scale>
          <a:sx n="131" d="100"/>
          <a:sy n="131" d="100"/>
        </p:scale>
        <p:origin x="629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7F9143-821F-4242-A36E-5C5318086E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E4AD1D-F88A-7143-8386-55FD4645E1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2C483-7029-A04F-9D52-A41D224D4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CA0A39-A080-B04F-92FD-ED9256124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7807B-F6E8-2D46-8480-F0507BCF2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331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9A4A1-7967-6349-852B-0FB1649C8E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8F9566-9511-DF42-A210-F4D8FA1217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6D6F5A-6F69-1549-996F-57471601E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20F239-4470-8144-9230-314B8E8E4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60B00-42BC-824E-8836-39F99B2B0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052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FD7CDE-B625-AC48-BE6E-3D999B5A39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E65C59-A23D-3D44-B356-FC963118B3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2B4343-D1B6-D042-91DE-3280767F2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C1B5D2-EB9A-7B46-B29F-6CF7DD451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6F5D6E-7480-3445-87DC-90F1092B5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445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B9C26-A201-E742-8AB7-E365C5C7BB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B74340-4ADD-B44C-B3B2-493D3591F5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459B97-B0BC-2541-B33E-8DB37CC0F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C0BA71-AF31-944A-BA98-86A88D7D6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34D4A0-C6E1-D54C-908C-BA5929F6D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950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08314-220B-A048-A384-7F67F21D0F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9538C3-07D9-E245-B993-507327E140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DF720B-6AD0-5B48-AF61-4542801E1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1D84C0-FEF6-9643-98F3-5930AF27E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4B308-A11F-A446-8EB1-D26C72F9E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116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788CB-E7AC-3E40-9E2B-FB834E247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B84063-E7B4-DC47-B5E8-308D1E491A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1C106D-18AC-CA40-97E1-AE2FF40D52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FFCE93-83DD-814B-BDEF-8D9BFCE6B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0ABB4A-BD3C-7F48-9337-D2FF7AC61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08F929-F61D-5D45-8225-9BCE6A6A8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213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DCEC10-853A-8841-89E7-50D5119524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F9FFFF-A03B-DD42-90AC-540B2764D9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B731E0-53B9-C249-8C12-F386AF946D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375AA7-AF49-4A4A-9454-8D7FFB32F9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D5F6BA-74A9-C444-BBB1-1C80EE31B5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1DD8F4-E9EC-354C-82D1-987091381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AB4C4-46B4-B046-A059-B37460EA9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24F886-C878-6243-B86D-40C008736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860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A5FE5-D113-7A40-81B1-B327C1C00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262FAC-A999-C243-BC97-AC7766667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53BE8F-39D2-4A47-BA6F-C7A7A24AA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14145A-C474-F441-AF33-BE19E690F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427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A415B3-5530-E94F-82A4-4DF15186D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6883C2-D264-A745-B221-D654F0CA8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E24464-650F-A94F-8F90-14FA99DFC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900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B795EA-D90A-4D45-B379-E2293B9D96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F13A23-A7C5-B542-BC03-02E52F1040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AEDC1E-C04A-7C43-AC51-99503869CB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9296C5-940A-E94C-B554-61B4FCC1E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C3A407-B50F-4047-AF55-CA51D6B2C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903419-51A6-9545-AD0D-3C0D22BC1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049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1C048-30AA-9D4D-A1DE-CB0FCC445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86D886-760D-4549-B417-B2329D8DEC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949DA8-F3D2-B74C-868F-23BBDB971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836EC2-33F3-8D4E-B63E-D1A53C65B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C327E0-8EEB-B545-AB94-D3414CBFE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8B8273-E56D-2D41-B73B-BB219ED3E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083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189534-3F02-A74D-8D90-9738F0B31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338882-2546-9841-B0FF-DD473C84EE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581E95-C83C-6841-9B86-66A637FF51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75DE0-8AB1-A440-AFED-DEBD1EC2C0D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BCA73-87C9-8846-9E06-56781D3656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275C16-0E7B-814E-B134-F9CF341B00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B0B6A-CD5B-EF4A-BDDD-F83EDEF0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95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75CC1DD-91B4-4E41-BC6B-FFFC5BDA96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372" y="146909"/>
            <a:ext cx="3686400" cy="66290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C4632DB-F2D3-0848-B2D6-449516207D32}"/>
              </a:ext>
            </a:extLst>
          </p:cNvPr>
          <p:cNvSpPr txBox="1"/>
          <p:nvPr/>
        </p:nvSpPr>
        <p:spPr>
          <a:xfrm>
            <a:off x="1521734" y="681136"/>
            <a:ext cx="13697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Adrenal </a:t>
            </a:r>
            <a:r>
              <a:rPr lang="en-US" sz="1600" dirty="0" smtClean="0"/>
              <a:t>gland</a:t>
            </a:r>
            <a:endParaRPr lang="en-US" sz="1600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A930C4F-59B9-9045-9C6E-2F5FFE3E95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7920" y="170085"/>
            <a:ext cx="3686400" cy="61273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C5B61F6-8C63-D34D-A604-4C38485A2F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4078" y="153629"/>
            <a:ext cx="3686400" cy="61274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7B60363-655C-AA4D-A5A5-06FB6BC800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433" y="982069"/>
            <a:ext cx="3686400" cy="61273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3591721-5B13-F44D-AC11-4C81A494CF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13910" y="920669"/>
            <a:ext cx="3686400" cy="61273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A398C91-AD6E-CB46-85FC-DC255D50D5C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5738" y="1721732"/>
            <a:ext cx="3686400" cy="61274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EAA37E0-9BC5-7941-AE42-54B1F45365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36029" y="1706258"/>
            <a:ext cx="3686400" cy="612739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E42EDAC-38E0-9C40-8D20-9A7BB7E193B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34077" y="1688827"/>
            <a:ext cx="3686400" cy="612739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CE1AEBB4-81BA-CA4C-9652-3B6100B1328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7318" y="2506530"/>
            <a:ext cx="3686400" cy="66290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BF35161F-B206-524D-9F97-A0F0DDF0506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13910" y="2538800"/>
            <a:ext cx="3686400" cy="61273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A75376C-C931-6B4A-9CE1-B8E026A24B6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034077" y="2452363"/>
            <a:ext cx="3686400" cy="66290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C68EA6BC-8B08-9349-BA41-0489A4165B4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5738" y="3324694"/>
            <a:ext cx="3686400" cy="61274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177120D-346F-724C-83D6-FF132F0702F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45418" y="3312024"/>
            <a:ext cx="3686400" cy="612739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A00D1FD1-8068-754C-AB6E-BBEF3192E5C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034188" y="3299253"/>
            <a:ext cx="3686400" cy="612739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3D783809-2951-3445-BEF5-A54D5E8DB45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97318" y="4120748"/>
            <a:ext cx="3686400" cy="612739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865663D9-626F-434D-A5B7-49127979384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157920" y="4048744"/>
            <a:ext cx="3686400" cy="612739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2AE2F353-73A0-D74D-A150-0AAB3997A14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034078" y="4024485"/>
            <a:ext cx="3686400" cy="612739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DEE680C6-AB3F-EC4E-8F4B-C96EC7BC145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6063" y="4875261"/>
            <a:ext cx="3686400" cy="61274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E18C2BF7-7B01-D141-90E6-5347481AC56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193749" y="4875841"/>
            <a:ext cx="3686400" cy="61274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0B45932A-E6B9-9E4F-8CA8-75AB5E8550A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089660" y="4865059"/>
            <a:ext cx="3686400" cy="61274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47F967B9-234F-B44B-9BB8-EC9E8D726D42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0902" y="5738022"/>
            <a:ext cx="5844785" cy="971498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2C98C393-9DC2-D84D-901F-93B757BD22F4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212018" y="5716416"/>
            <a:ext cx="5844791" cy="971499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6BFD7ED1-767F-F148-91B0-C6E71329802D}"/>
              </a:ext>
            </a:extLst>
          </p:cNvPr>
          <p:cNvSpPr txBox="1"/>
          <p:nvPr/>
        </p:nvSpPr>
        <p:spPr>
          <a:xfrm>
            <a:off x="5465661" y="635564"/>
            <a:ext cx="1027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rainstem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22C3401-809D-514D-ADC9-D398936E2D66}"/>
              </a:ext>
            </a:extLst>
          </p:cNvPr>
          <p:cNvSpPr txBox="1"/>
          <p:nvPr/>
        </p:nvSpPr>
        <p:spPr>
          <a:xfrm>
            <a:off x="9306192" y="643132"/>
            <a:ext cx="1142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Cerebellum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CA60024-2E70-614A-BD44-6B338D220DC9}"/>
              </a:ext>
            </a:extLst>
          </p:cNvPr>
          <p:cNvSpPr txBox="1"/>
          <p:nvPr/>
        </p:nvSpPr>
        <p:spPr>
          <a:xfrm>
            <a:off x="1649567" y="1443065"/>
            <a:ext cx="1018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Cerebrum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28F9E9E-D1FE-D94B-8120-B0C56D912203}"/>
              </a:ext>
            </a:extLst>
          </p:cNvPr>
          <p:cNvSpPr txBox="1"/>
          <p:nvPr/>
        </p:nvSpPr>
        <p:spPr>
          <a:xfrm>
            <a:off x="9306192" y="1380559"/>
            <a:ext cx="13314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Bone </a:t>
            </a:r>
            <a:r>
              <a:rPr lang="en-US" sz="1600" dirty="0" smtClean="0"/>
              <a:t>marrow</a:t>
            </a:r>
            <a:endParaRPr lang="en-US" sz="16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22BC3C4-FAA9-CB4C-8074-498689ED5CBB}"/>
              </a:ext>
            </a:extLst>
          </p:cNvPr>
          <p:cNvSpPr txBox="1"/>
          <p:nvPr/>
        </p:nvSpPr>
        <p:spPr>
          <a:xfrm>
            <a:off x="1766697" y="3024175"/>
            <a:ext cx="7476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Kidney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AB1D6E0-5D2D-D94E-B1CF-5E4090BEC4A8}"/>
              </a:ext>
            </a:extLst>
          </p:cNvPr>
          <p:cNvSpPr txBox="1"/>
          <p:nvPr/>
        </p:nvSpPr>
        <p:spPr>
          <a:xfrm>
            <a:off x="1472608" y="3808201"/>
            <a:ext cx="13133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Lymph </a:t>
            </a:r>
            <a:r>
              <a:rPr lang="en-US" sz="1600" dirty="0" smtClean="0"/>
              <a:t>nodes</a:t>
            </a:r>
            <a:endParaRPr lang="en-US" sz="16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2DB0264-B5B2-5F40-9A35-06DEBB9BBFD1}"/>
              </a:ext>
            </a:extLst>
          </p:cNvPr>
          <p:cNvSpPr txBox="1"/>
          <p:nvPr/>
        </p:nvSpPr>
        <p:spPr>
          <a:xfrm>
            <a:off x="1688242" y="4604541"/>
            <a:ext cx="877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Prostate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1CCF867-AEDD-FE49-A5BF-A53284E9735D}"/>
              </a:ext>
            </a:extLst>
          </p:cNvPr>
          <p:cNvSpPr txBox="1"/>
          <p:nvPr/>
        </p:nvSpPr>
        <p:spPr>
          <a:xfrm>
            <a:off x="1636336" y="5331809"/>
            <a:ext cx="9104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Stomach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08BA074-E7D3-AD4F-8259-B786BB44721F}"/>
              </a:ext>
            </a:extLst>
          </p:cNvPr>
          <p:cNvSpPr txBox="1"/>
          <p:nvPr/>
        </p:nvSpPr>
        <p:spPr>
          <a:xfrm>
            <a:off x="5668234" y="1386564"/>
            <a:ext cx="745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Uterus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62827EC-A7C8-B645-8B2E-487CB0842630}"/>
              </a:ext>
            </a:extLst>
          </p:cNvPr>
          <p:cNvSpPr txBox="1"/>
          <p:nvPr/>
        </p:nvSpPr>
        <p:spPr>
          <a:xfrm>
            <a:off x="1831764" y="2156645"/>
            <a:ext cx="6543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Hear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C315C83-8E69-BB4C-9A30-EF18489BCA11}"/>
              </a:ext>
            </a:extLst>
          </p:cNvPr>
          <p:cNvSpPr txBox="1"/>
          <p:nvPr/>
        </p:nvSpPr>
        <p:spPr>
          <a:xfrm>
            <a:off x="5305256" y="2164699"/>
            <a:ext cx="1391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Hypothalamu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AFF6267-8116-C94B-9384-A372336018D2}"/>
              </a:ext>
            </a:extLst>
          </p:cNvPr>
          <p:cNvSpPr txBox="1"/>
          <p:nvPr/>
        </p:nvSpPr>
        <p:spPr>
          <a:xfrm>
            <a:off x="5726080" y="3006450"/>
            <a:ext cx="583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Liver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DD30339-9E04-DC46-8B8E-B57B852CD816}"/>
              </a:ext>
            </a:extLst>
          </p:cNvPr>
          <p:cNvSpPr txBox="1"/>
          <p:nvPr/>
        </p:nvSpPr>
        <p:spPr>
          <a:xfrm>
            <a:off x="5476619" y="3783060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Soft </a:t>
            </a:r>
            <a:r>
              <a:rPr lang="en-US" sz="1600" dirty="0" smtClean="0"/>
              <a:t>tissue</a:t>
            </a:r>
            <a:endParaRPr lang="en-US" sz="16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859C7D0-567B-AA4F-859B-9DBC89ED6C01}"/>
              </a:ext>
            </a:extLst>
          </p:cNvPr>
          <p:cNvSpPr txBox="1"/>
          <p:nvPr/>
        </p:nvSpPr>
        <p:spPr>
          <a:xfrm>
            <a:off x="5646481" y="4507652"/>
            <a:ext cx="822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Rectum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102AE9D-E16F-EA4C-9650-FFF37C3BBB62}"/>
              </a:ext>
            </a:extLst>
          </p:cNvPr>
          <p:cNvSpPr txBox="1"/>
          <p:nvPr/>
        </p:nvSpPr>
        <p:spPr>
          <a:xfrm>
            <a:off x="5775078" y="5340631"/>
            <a:ext cx="6418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Testi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5CCE782-5AB7-644B-AF5F-C22D4CE7F3B7}"/>
              </a:ext>
            </a:extLst>
          </p:cNvPr>
          <p:cNvSpPr txBox="1"/>
          <p:nvPr/>
        </p:nvSpPr>
        <p:spPr>
          <a:xfrm>
            <a:off x="9397844" y="2156645"/>
            <a:ext cx="9277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Pancreas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881A0C0-C726-2948-914F-93AB1E73F2F5}"/>
              </a:ext>
            </a:extLst>
          </p:cNvPr>
          <p:cNvSpPr txBox="1"/>
          <p:nvPr/>
        </p:nvSpPr>
        <p:spPr>
          <a:xfrm>
            <a:off x="9603966" y="2992134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Lung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0CAC069-ABE9-364F-9282-D167D4F44BBB}"/>
              </a:ext>
            </a:extLst>
          </p:cNvPr>
          <p:cNvSpPr txBox="1"/>
          <p:nvPr/>
        </p:nvSpPr>
        <p:spPr>
          <a:xfrm>
            <a:off x="9574488" y="3774343"/>
            <a:ext cx="6748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Ovary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8574BB6-DBBA-5148-81D1-294F03850FE8}"/>
              </a:ext>
            </a:extLst>
          </p:cNvPr>
          <p:cNvSpPr txBox="1"/>
          <p:nvPr/>
        </p:nvSpPr>
        <p:spPr>
          <a:xfrm>
            <a:off x="9657732" y="4508131"/>
            <a:ext cx="5261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Skin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9135ECC-2203-9C4B-B31E-14C70F4F9A97}"/>
              </a:ext>
            </a:extLst>
          </p:cNvPr>
          <p:cNvSpPr txBox="1"/>
          <p:nvPr/>
        </p:nvSpPr>
        <p:spPr>
          <a:xfrm>
            <a:off x="9526691" y="5331809"/>
            <a:ext cx="812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Thyroid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589905D-0B8D-3947-95D8-CC63D2633240}"/>
              </a:ext>
            </a:extLst>
          </p:cNvPr>
          <p:cNvSpPr txBox="1"/>
          <p:nvPr/>
        </p:nvSpPr>
        <p:spPr>
          <a:xfrm>
            <a:off x="2466751" y="6492536"/>
            <a:ext cx="1498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Urinary </a:t>
            </a:r>
            <a:r>
              <a:rPr lang="en-US" sz="1600" dirty="0" smtClean="0"/>
              <a:t>bladder</a:t>
            </a:r>
            <a:endParaRPr lang="en-US" sz="16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B9EF85A-3D4D-794A-928F-1C8A3E502AD3}"/>
              </a:ext>
            </a:extLst>
          </p:cNvPr>
          <p:cNvSpPr txBox="1"/>
          <p:nvPr/>
        </p:nvSpPr>
        <p:spPr>
          <a:xfrm>
            <a:off x="8640625" y="6470909"/>
            <a:ext cx="665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Col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9773573-48E0-BB45-A6CC-2BD0AF67BA34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8042838" y="904881"/>
            <a:ext cx="3686400" cy="612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8114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28</Words>
  <Application>Microsoft Office PowerPoint</Application>
  <PresentationFormat>宽屏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g, Bowen</dc:creator>
  <cp:lastModifiedBy>NTKO</cp:lastModifiedBy>
  <cp:revision>10</cp:revision>
  <dcterms:created xsi:type="dcterms:W3CDTF">2021-12-14T02:43:44Z</dcterms:created>
  <dcterms:modified xsi:type="dcterms:W3CDTF">2022-08-30T09:13:26Z</dcterms:modified>
</cp:coreProperties>
</file>